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ll" initials="D" lastIdx="1" clrIdx="0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66" d="100"/>
          <a:sy n="66" d="100"/>
        </p:scale>
        <p:origin x="1998" y="-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357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0424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14713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5333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6272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6771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0702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398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653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30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9031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F3D77-2394-4305-BBE0-3E290C37756F}" type="datetimeFigureOut">
              <a:rPr lang="en-IN" smtClean="0"/>
              <a:t>29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16836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948C52BB-8AD1-4352-8F9C-B520A2222F5C}"/>
              </a:ext>
            </a:extLst>
          </p:cNvPr>
          <p:cNvGrpSpPr/>
          <p:nvPr/>
        </p:nvGrpSpPr>
        <p:grpSpPr>
          <a:xfrm>
            <a:off x="0" y="1734729"/>
            <a:ext cx="6858000" cy="5151520"/>
            <a:chOff x="0" y="1734729"/>
            <a:chExt cx="6858000" cy="5151520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E8BFF5F-A104-43EF-BF48-E59C636963EF}"/>
                </a:ext>
              </a:extLst>
            </p:cNvPr>
            <p:cNvSpPr txBox="1"/>
            <p:nvPr/>
          </p:nvSpPr>
          <p:spPr>
            <a:xfrm>
              <a:off x="0" y="4999899"/>
              <a:ext cx="6858000" cy="188635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200000"/>
                </a:lnSpc>
              </a:pPr>
              <a:r>
                <a:rPr lang="en-IN" sz="12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. 3 Original/uncropped full-length gel of figure 6 (in the main manuscript). </a:t>
              </a:r>
              <a:r>
                <a:rPr lang="en-IN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he cropped part of the gel is mentioned as a red line (</a:t>
              </a:r>
              <a:r>
                <a:rPr lang="en-IN" sz="1200" kern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presenting</a:t>
              </a:r>
              <a:r>
                <a:rPr lang="en-IN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ontrol and PCOS group in the main manuscript). </a:t>
              </a:r>
              <a:r>
                <a:rPr lang="en-IN" sz="1200" kern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ands observed outside the red lines are from different tissues (These tissues are not relevant to this manuscript). </a:t>
              </a:r>
              <a:r>
                <a:rPr lang="en-IN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he full-length gel picture is</a:t>
              </a:r>
              <a:r>
                <a:rPr lang="en-IN" sz="1200" kern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original without any type of editing.</a:t>
              </a:r>
              <a:endParaRPr lang="en-IN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just">
                <a:lnSpc>
                  <a:spcPct val="200000"/>
                </a:lnSpc>
              </a:pPr>
              <a:r>
                <a:rPr lang="en-IN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endParaRPr lang="en-IN" sz="1200" dirty="0"/>
            </a:p>
          </p:txBody>
        </p: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BBF0EB47-2DF6-41C8-A2CE-FBD2C2F0D4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21" t="13762" r="17766" b="4890"/>
            <a:stretch/>
          </p:blipFill>
          <p:spPr bwMode="auto">
            <a:xfrm>
              <a:off x="1157061" y="1734729"/>
              <a:ext cx="4108450" cy="326517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13FC559-CC8F-458A-ADC0-3BD3A73FBC75}"/>
                </a:ext>
              </a:extLst>
            </p:cNvPr>
            <p:cNvSpPr/>
            <p:nvPr/>
          </p:nvSpPr>
          <p:spPr>
            <a:xfrm>
              <a:off x="3106965" y="2464544"/>
              <a:ext cx="876300" cy="23190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IN"/>
            </a:p>
          </p:txBody>
        </p:sp>
        <p:sp>
          <p:nvSpPr>
            <p:cNvPr id="28" name="TextBox 29">
              <a:extLst>
                <a:ext uri="{FF2B5EF4-FFF2-40B4-BE49-F238E27FC236}">
                  <a16:creationId xmlns:a16="http://schemas.microsoft.com/office/drawing/2014/main" id="{1F8987EA-4541-4034-B450-0BF7C903FDF4}"/>
                </a:ext>
              </a:extLst>
            </p:cNvPr>
            <p:cNvSpPr txBox="1"/>
            <p:nvPr/>
          </p:nvSpPr>
          <p:spPr>
            <a:xfrm>
              <a:off x="4988006" y="3126560"/>
              <a:ext cx="1323340" cy="30734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fontAlgn="base">
                <a:lnSpc>
                  <a:spcPct val="107000"/>
                </a:lnSpc>
                <a:spcAft>
                  <a:spcPts val="800"/>
                </a:spcAft>
              </a:pPr>
              <a:r>
                <a:rPr lang="en-IN" sz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MP-9</a:t>
              </a:r>
              <a:endParaRPr lang="en-IN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CF4C2A7B-5896-4560-A2AA-CB5425B3EC7E}"/>
                </a:ext>
              </a:extLst>
            </p:cNvPr>
            <p:cNvCxnSpPr/>
            <p:nvPr/>
          </p:nvCxnSpPr>
          <p:spPr>
            <a:xfrm>
              <a:off x="3916670" y="3288485"/>
              <a:ext cx="10858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0">
              <a:extLst>
                <a:ext uri="{FF2B5EF4-FFF2-40B4-BE49-F238E27FC236}">
                  <a16:creationId xmlns:a16="http://schemas.microsoft.com/office/drawing/2014/main" id="{D2ECD773-F7D3-42E5-8241-EBAB2C046126}"/>
                </a:ext>
              </a:extLst>
            </p:cNvPr>
            <p:cNvSpPr txBox="1"/>
            <p:nvPr/>
          </p:nvSpPr>
          <p:spPr>
            <a:xfrm>
              <a:off x="4944907" y="3592016"/>
              <a:ext cx="1085850" cy="3073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fontAlgn="base">
                <a:lnSpc>
                  <a:spcPct val="107000"/>
                </a:lnSpc>
                <a:spcAft>
                  <a:spcPts val="800"/>
                </a:spcAft>
              </a:pPr>
              <a:r>
                <a:rPr lang="en-IN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o MMP-2  </a:t>
              </a:r>
              <a:endPara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0">
              <a:extLst>
                <a:ext uri="{FF2B5EF4-FFF2-40B4-BE49-F238E27FC236}">
                  <a16:creationId xmlns:a16="http://schemas.microsoft.com/office/drawing/2014/main" id="{32321918-89B8-4A04-B93E-5D8C66D93C42}"/>
                </a:ext>
              </a:extLst>
            </p:cNvPr>
            <p:cNvSpPr txBox="1"/>
            <p:nvPr/>
          </p:nvSpPr>
          <p:spPr>
            <a:xfrm>
              <a:off x="4941179" y="3879577"/>
              <a:ext cx="1279171" cy="30734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fontAlgn="base">
                <a:lnSpc>
                  <a:spcPct val="107000"/>
                </a:lnSpc>
                <a:spcAft>
                  <a:spcPts val="800"/>
                </a:spcAft>
              </a:pPr>
              <a:r>
                <a:rPr lang="en-IN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ctive</a:t>
              </a:r>
              <a:r>
                <a:rPr lang="en-IN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MMP-2  </a:t>
              </a:r>
              <a:endPara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8602FF1E-65CA-4FE8-9E2D-F0211D0DBF6B}"/>
                </a:ext>
              </a:extLst>
            </p:cNvPr>
            <p:cNvCxnSpPr>
              <a:cxnSpLocks/>
            </p:cNvCxnSpPr>
            <p:nvPr/>
          </p:nvCxnSpPr>
          <p:spPr>
            <a:xfrm>
              <a:off x="3967472" y="3745683"/>
              <a:ext cx="9774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BEBB70FB-F207-4DB9-892F-C385F4A075D0}"/>
                </a:ext>
              </a:extLst>
            </p:cNvPr>
            <p:cNvCxnSpPr>
              <a:cxnSpLocks/>
            </p:cNvCxnSpPr>
            <p:nvPr/>
          </p:nvCxnSpPr>
          <p:spPr>
            <a:xfrm>
              <a:off x="3985161" y="3942710"/>
              <a:ext cx="9774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97879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4</TotalTime>
  <Words>7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22</cp:revision>
  <dcterms:created xsi:type="dcterms:W3CDTF">2022-04-15T09:53:27Z</dcterms:created>
  <dcterms:modified xsi:type="dcterms:W3CDTF">2022-04-29T11:17:28Z</dcterms:modified>
</cp:coreProperties>
</file>